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66" r:id="rId3"/>
    <p:sldId id="267" r:id="rId4"/>
    <p:sldId id="261" r:id="rId5"/>
    <p:sldId id="268" r:id="rId6"/>
    <p:sldId id="262" r:id="rId7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1560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961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736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242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625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275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848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310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028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67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265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303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A0E61-AAB7-4E8B-8F11-9B0042FBBF36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7D06A-05CC-40D6-9280-EB2F1ECD6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949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558103" y="1234460"/>
            <a:ext cx="3362813" cy="3443815"/>
            <a:chOff x="1040745" y="1142119"/>
            <a:chExt cx="5355902" cy="5517323"/>
          </a:xfrm>
        </p:grpSpPr>
        <p:grpSp>
          <p:nvGrpSpPr>
            <p:cNvPr id="2" name="Group 1"/>
            <p:cNvGrpSpPr/>
            <p:nvPr/>
          </p:nvGrpSpPr>
          <p:grpSpPr>
            <a:xfrm>
              <a:off x="1040746" y="1142119"/>
              <a:ext cx="2649951" cy="2697679"/>
              <a:chOff x="0" y="-20447"/>
              <a:chExt cx="1967230" cy="2046732"/>
            </a:xfrm>
          </p:grpSpPr>
          <p:pic>
            <p:nvPicPr>
              <p:cNvPr id="12" name="Picture 11" descr="A screenshot of a computer&#10;&#10;Description automatically generated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384" t="24725" r="23566" b="7439"/>
              <a:stretch/>
            </p:blipFill>
            <p:spPr bwMode="auto">
              <a:xfrm>
                <a:off x="0" y="0"/>
                <a:ext cx="1967230" cy="2026285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13" name="Text Box 1"/>
              <p:cNvSpPr txBox="1"/>
              <p:nvPr/>
            </p:nvSpPr>
            <p:spPr>
              <a:xfrm>
                <a:off x="80692" y="-20447"/>
                <a:ext cx="266700" cy="27305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HK" dirty="0">
                    <a:solidFill>
                      <a:srgbClr val="FFFFFF"/>
                    </a:solidFill>
                    <a:effectLst>
                      <a:outerShdw blurRad="38100" dist="19050" dir="2700000" algn="tl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ea typeface="DengXian"/>
                    <a:cs typeface="Times New Roman" panose="02020603050405020304" pitchFamily="18" charset="0"/>
                  </a:rPr>
                  <a:t>A</a:t>
                </a:r>
                <a:endParaRPr lang="en-US" sz="1600" dirty="0">
                  <a:effectLst/>
                  <a:latin typeface="Times New Roman" panose="02020603050405020304" pitchFamily="18" charset="0"/>
                  <a:ea typeface="DengXian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0" name="Picture 9" descr="A screenshot of a computer screen&#10;&#10;Description automatically generated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77" t="25600" r="25064" b="9848"/>
            <a:stretch/>
          </p:blipFill>
          <p:spPr bwMode="auto">
            <a:xfrm>
              <a:off x="3762274" y="1169069"/>
              <a:ext cx="2626496" cy="2661523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8" name="Picture 7" descr="A screenshot of a computer&#10;&#10;Description automatically generated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265" t="22539" r="23296" b="7227"/>
            <a:stretch/>
          </p:blipFill>
          <p:spPr bwMode="auto">
            <a:xfrm>
              <a:off x="1040745" y="3930963"/>
              <a:ext cx="2640917" cy="2726805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6" name="Picture 5" descr="A screenshot of a computer&#10;&#10;Description automatically generated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512" t="23414" r="24800" b="8541"/>
            <a:stretch/>
          </p:blipFill>
          <p:spPr bwMode="auto">
            <a:xfrm>
              <a:off x="3797163" y="3930963"/>
              <a:ext cx="2599484" cy="2728479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14" name="TextBox 13"/>
          <p:cNvSpPr txBox="1"/>
          <p:nvPr/>
        </p:nvSpPr>
        <p:spPr>
          <a:xfrm>
            <a:off x="705763" y="648109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 Box 1"/>
          <p:cNvSpPr txBox="1"/>
          <p:nvPr/>
        </p:nvSpPr>
        <p:spPr>
          <a:xfrm>
            <a:off x="3271137" y="1251281"/>
            <a:ext cx="359257" cy="336377"/>
          </a:xfrm>
          <a:prstGeom prst="rect">
            <a:avLst/>
          </a:prstGeom>
          <a:noFill/>
          <a:ln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HK" dirty="0">
                <a:solidFill>
                  <a:srgbClr val="FFFFFF"/>
                </a:solidFill>
                <a:effectLst>
                  <a:outerShdw blurRad="38100" dist="19050" dir="2700000" algn="tl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B</a:t>
            </a:r>
            <a:endParaRPr lang="en-US" sz="1600" dirty="0">
              <a:effectLst/>
              <a:latin typeface="Times New Roman" panose="02020603050405020304" pitchFamily="18" charset="0"/>
              <a:ea typeface="DengXian"/>
              <a:cs typeface="Times New Roman" panose="02020603050405020304" pitchFamily="18" charset="0"/>
            </a:endParaRPr>
          </a:p>
        </p:txBody>
      </p:sp>
      <p:sp>
        <p:nvSpPr>
          <p:cNvPr id="16" name="Text Box 1"/>
          <p:cNvSpPr txBox="1"/>
          <p:nvPr/>
        </p:nvSpPr>
        <p:spPr>
          <a:xfrm>
            <a:off x="3261481" y="2979991"/>
            <a:ext cx="359257" cy="336377"/>
          </a:xfrm>
          <a:prstGeom prst="rect">
            <a:avLst/>
          </a:prstGeom>
          <a:noFill/>
          <a:ln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HK" dirty="0">
                <a:solidFill>
                  <a:srgbClr val="FFFFFF"/>
                </a:solidFill>
                <a:effectLst>
                  <a:outerShdw blurRad="38100" dist="19050" dir="2700000" algn="tl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D</a:t>
            </a:r>
            <a:endParaRPr lang="en-US" sz="1600" dirty="0">
              <a:effectLst/>
              <a:latin typeface="Times New Roman" panose="02020603050405020304" pitchFamily="18" charset="0"/>
              <a:ea typeface="DengXian"/>
              <a:cs typeface="Times New Roman" panose="02020603050405020304" pitchFamily="18" charset="0"/>
            </a:endParaRPr>
          </a:p>
        </p:txBody>
      </p:sp>
      <p:sp>
        <p:nvSpPr>
          <p:cNvPr id="17" name="Text Box 1"/>
          <p:cNvSpPr txBox="1"/>
          <p:nvPr/>
        </p:nvSpPr>
        <p:spPr>
          <a:xfrm>
            <a:off x="1554529" y="2979991"/>
            <a:ext cx="359257" cy="336377"/>
          </a:xfrm>
          <a:prstGeom prst="rect">
            <a:avLst/>
          </a:prstGeom>
          <a:noFill/>
          <a:ln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HK" dirty="0">
                <a:solidFill>
                  <a:srgbClr val="FFFFFF"/>
                </a:solidFill>
                <a:effectLst>
                  <a:outerShdw blurRad="38100" dist="19050" dir="2700000" algn="tl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C</a:t>
            </a:r>
            <a:endParaRPr lang="en-US" sz="1600" dirty="0">
              <a:effectLst/>
              <a:latin typeface="Times New Roman" panose="02020603050405020304" pitchFamily="18" charset="0"/>
              <a:ea typeface="DengXian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23330" y="4844965"/>
            <a:ext cx="288869" cy="376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8" descr="E:\pwhcase3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2199" y="4978179"/>
            <a:ext cx="2416801" cy="1825092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Picture 19" descr="E:\pwhcaseCD34.jpg"/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939"/>
          <a:stretch/>
        </p:blipFill>
        <p:spPr bwMode="auto">
          <a:xfrm>
            <a:off x="3891876" y="4986241"/>
            <a:ext cx="2420213" cy="1801487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Picture 20" descr="E:\pwhcaseBRAF.jpg"/>
          <p:cNvPicPr/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78" r="2176"/>
          <a:stretch/>
        </p:blipFill>
        <p:spPr bwMode="auto">
          <a:xfrm>
            <a:off x="1012199" y="7039423"/>
            <a:ext cx="2406565" cy="1823724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Picture 21" descr="C:\Users\HK Ng\AppData\Local\Temp\Temp1_EGFR Photos to Prof. Ng.zip\EGFR Photos to Prof. Ng\19S16078 EGFR -b.JPG"/>
          <p:cNvPicPr/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08" t="16529" r="11958" b="15237"/>
          <a:stretch/>
        </p:blipFill>
        <p:spPr bwMode="auto">
          <a:xfrm>
            <a:off x="3891876" y="7040290"/>
            <a:ext cx="2420213" cy="1821989"/>
          </a:xfrm>
          <a:prstGeom prst="rect">
            <a:avLst/>
          </a:prstGeom>
          <a:noFill/>
          <a:ln>
            <a:noFill/>
          </a:ln>
        </p:spPr>
      </p:pic>
      <p:sp>
        <p:nvSpPr>
          <p:cNvPr id="23" name="TextBox 22"/>
          <p:cNvSpPr txBox="1"/>
          <p:nvPr/>
        </p:nvSpPr>
        <p:spPr>
          <a:xfrm>
            <a:off x="3485959" y="4844965"/>
            <a:ext cx="288869" cy="376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25602" y="6867115"/>
            <a:ext cx="288869" cy="376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488231" y="6867115"/>
            <a:ext cx="288869" cy="376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8741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448372" y="108745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 descr="E:\1583-1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366" y="1449965"/>
            <a:ext cx="2900475" cy="2524458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/>
          <p:cNvSpPr txBox="1"/>
          <p:nvPr/>
        </p:nvSpPr>
        <p:spPr>
          <a:xfrm>
            <a:off x="3493094" y="109592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 descr="E:\1583-CD34.jp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36"/>
          <a:stretch/>
        </p:blipFill>
        <p:spPr bwMode="auto">
          <a:xfrm>
            <a:off x="3597006" y="1441750"/>
            <a:ext cx="2966035" cy="2540888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TextBox 11"/>
          <p:cNvSpPr txBox="1"/>
          <p:nvPr/>
        </p:nvSpPr>
        <p:spPr>
          <a:xfrm>
            <a:off x="739882" y="648109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43820" y="409907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488542" y="410753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Picture 19" descr="D:\eudora\attach\EGFR Cluster - b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091" r="19592" b="13624"/>
          <a:stretch/>
        </p:blipFill>
        <p:spPr bwMode="auto">
          <a:xfrm>
            <a:off x="571786" y="4468402"/>
            <a:ext cx="2871634" cy="2480811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Picture 20" descr="C:\Users\HK Ng\AppData\Local\Temp\Temp1_Met photos to Prof. Ng.zip\Met photos to Prof. Ng\Met 2011-1583 (Amp).JPG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8" b="9371"/>
          <a:stretch/>
        </p:blipFill>
        <p:spPr bwMode="auto">
          <a:xfrm>
            <a:off x="3597006" y="4476870"/>
            <a:ext cx="2889886" cy="248081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19098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E:\640-3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511" y="1412384"/>
            <a:ext cx="2981215" cy="2449932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/>
          <p:cNvSpPr txBox="1"/>
          <p:nvPr/>
        </p:nvSpPr>
        <p:spPr>
          <a:xfrm>
            <a:off x="739882" y="648109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48372" y="108745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493094" y="109592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43820" y="409907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488542" y="410753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Picture 19" descr="E:\640-CD34.jp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52" t="1" r="11173" b="6893"/>
          <a:stretch/>
        </p:blipFill>
        <p:spPr bwMode="auto">
          <a:xfrm>
            <a:off x="3648723" y="1419470"/>
            <a:ext cx="2981215" cy="2442846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Picture 20" descr="C:\Users\HK Ng\AppData\Local\Temp\Temp1_More EGFR p6 photos.zip\More EGFR p6 photos\EGFR p6 Amp -a (2009-640)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7798" r="20784" b="18810"/>
          <a:stretch/>
        </p:blipFill>
        <p:spPr bwMode="auto">
          <a:xfrm>
            <a:off x="456510" y="4432227"/>
            <a:ext cx="2996373" cy="2442846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Picture 21" descr="C:\Users\HK Ng\AppData\Local\Temp\Temp1_Met photos to Prof. Ng.zip\Met photos to Prof. Ng\Met 2009-0640 (p4).JPG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07" t="10905" r="16840" b="15270"/>
          <a:stretch/>
        </p:blipFill>
        <p:spPr bwMode="auto">
          <a:xfrm>
            <a:off x="3662371" y="4432226"/>
            <a:ext cx="2967567" cy="244284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140571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1328473" y="1469219"/>
            <a:ext cx="2257661" cy="2222292"/>
            <a:chOff x="1806339" y="1706617"/>
            <a:chExt cx="2257661" cy="222229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06339" y="2454146"/>
              <a:ext cx="2257661" cy="1474763"/>
            </a:xfrm>
            <a:prstGeom prst="rect">
              <a:avLst/>
            </a:prstGeom>
          </p:spPr>
        </p:pic>
        <p:cxnSp>
          <p:nvCxnSpPr>
            <p:cNvPr id="7" name="Straight Arrow Connector 6"/>
            <p:cNvCxnSpPr/>
            <p:nvPr/>
          </p:nvCxnSpPr>
          <p:spPr>
            <a:xfrm>
              <a:off x="2892054" y="2046617"/>
              <a:ext cx="2381" cy="45005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2542922" y="1706617"/>
              <a:ext cx="13853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TG</a:t>
              </a:r>
              <a:r>
                <a:rPr lang="en-HK" dirty="0">
                  <a:latin typeface="Times New Roman" panose="02020603050405020304" pitchFamily="18" charset="0"/>
                  <a:cs typeface="Times New Roman" panose="02020603050405020304" pitchFamily="18" charset="0"/>
                  <a:sym typeface="Wingdings" panose="05000000000000000000" pitchFamily="2" charset="2"/>
                </a:rPr>
                <a:t>GAG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739882" y="648109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69829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3882" y="253181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7913" r="3446"/>
          <a:stretch/>
        </p:blipFill>
        <p:spPr>
          <a:xfrm>
            <a:off x="173882" y="1605911"/>
            <a:ext cx="6508735" cy="62357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1339" y="1082691"/>
            <a:ext cx="64512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supervised clustering of DNA methylation patterns of 991 reference samples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four of samples in this study using the 15,000 most variably methylated prob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334568" y="7639857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 Ref. 1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39972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39"/>
          <p:cNvGrpSpPr/>
          <p:nvPr/>
        </p:nvGrpSpPr>
        <p:grpSpPr>
          <a:xfrm>
            <a:off x="1990192" y="1210444"/>
            <a:ext cx="2913469" cy="7670229"/>
            <a:chOff x="1990192" y="1210444"/>
            <a:chExt cx="2913469" cy="7670229"/>
          </a:xfrm>
        </p:grpSpPr>
        <p:grpSp>
          <p:nvGrpSpPr>
            <p:cNvPr id="17" name="Group 16"/>
            <p:cNvGrpSpPr/>
            <p:nvPr/>
          </p:nvGrpSpPr>
          <p:grpSpPr>
            <a:xfrm rot="5400000">
              <a:off x="-320929" y="3521565"/>
              <a:ext cx="7499857" cy="2877616"/>
              <a:chOff x="280041" y="4119155"/>
              <a:chExt cx="6469102" cy="2877616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280041" y="4119155"/>
                <a:ext cx="6469102" cy="2877616"/>
                <a:chOff x="0" y="2926695"/>
                <a:chExt cx="7633199" cy="4226829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0" y="2926695"/>
                  <a:ext cx="7633199" cy="4226829"/>
                </a:xfrm>
                <a:prstGeom prst="rect">
                  <a:avLst/>
                </a:prstGeom>
                <a:ln w="19812">
                  <a:solidFill>
                    <a:schemeClr val="tx1"/>
                  </a:solidFill>
                </a:ln>
              </p:spPr>
            </p:pic>
            <p:sp>
              <p:nvSpPr>
                <p:cNvPr id="10" name="Rectangle 9"/>
                <p:cNvSpPr/>
                <p:nvPr/>
              </p:nvSpPr>
              <p:spPr>
                <a:xfrm>
                  <a:off x="0" y="3483429"/>
                  <a:ext cx="1175385" cy="367009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40288" y="4030717"/>
                  <a:ext cx="1053921" cy="6083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HK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NV</a:t>
                  </a:r>
                </a:p>
                <a:p>
                  <a:pPr algn="ctr"/>
                  <a:r>
                    <a:rPr lang="en-HK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summary</a:t>
                  </a:r>
                  <a:endPara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0" y="5728300"/>
                  <a:ext cx="81785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HK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tient 1</a:t>
                  </a:r>
                  <a:endPara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0" y="6066105"/>
                  <a:ext cx="81785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HK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tient 2</a:t>
                  </a:r>
                  <a:endPara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4348" y="6411925"/>
                  <a:ext cx="81785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HK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tient 3</a:t>
                  </a:r>
                  <a:endPara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4348" y="6723603"/>
                  <a:ext cx="81785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HK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tient 4</a:t>
                  </a:r>
                  <a:endPara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6" name="Rectangle 15"/>
              <p:cNvSpPr/>
              <p:nvPr/>
            </p:nvSpPr>
            <p:spPr>
              <a:xfrm>
                <a:off x="1367246" y="4119155"/>
                <a:ext cx="5381897" cy="21771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 rot="5400000">
              <a:off x="4483214" y="8577787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5400000">
              <a:off x="4592069" y="8434099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5400000">
              <a:off x="4487561" y="8355721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5400000">
              <a:off x="4596416" y="8220742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5400000">
              <a:off x="4491910" y="8073321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5400000">
              <a:off x="4600765" y="7916220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5400000">
              <a:off x="4598308" y="7522582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5400000">
              <a:off x="4492478" y="7719085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5400000">
              <a:off x="4496827" y="7289205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5400000">
              <a:off x="4598308" y="7036233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5400000">
              <a:off x="4494373" y="6792679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5400000">
              <a:off x="4595854" y="6488089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5400000">
              <a:off x="4600774" y="5895696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rot="5400000">
              <a:off x="4499291" y="6200286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5400000">
              <a:off x="4598316" y="5251685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5400000">
              <a:off x="4496833" y="5556275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5400000">
              <a:off x="4595858" y="4578179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5400000">
              <a:off x="4494375" y="4882769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5400000">
              <a:off x="4593403" y="3698199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5400000">
              <a:off x="4491920" y="4120776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5400000">
              <a:off x="4590945" y="2714977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5400000">
              <a:off x="4489462" y="3189172"/>
              <a:ext cx="3903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1" name="TextBox 40"/>
          <p:cNvSpPr txBox="1"/>
          <p:nvPr/>
        </p:nvSpPr>
        <p:spPr>
          <a:xfrm rot="5400000">
            <a:off x="4601505" y="1299928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1901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29</TotalTime>
  <Words>99</Words>
  <Application>Microsoft Office PowerPoint</Application>
  <PresentationFormat>A4 Paper (210x297 mm)</PresentationFormat>
  <Paragraphs>5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y Ka Wai Li</dc:creator>
  <cp:lastModifiedBy>Begam, Shalima -</cp:lastModifiedBy>
  <cp:revision>30</cp:revision>
  <cp:lastPrinted>2020-09-24T06:52:40Z</cp:lastPrinted>
  <dcterms:created xsi:type="dcterms:W3CDTF">2020-06-18T04:04:35Z</dcterms:created>
  <dcterms:modified xsi:type="dcterms:W3CDTF">2020-09-25T09:25:03Z</dcterms:modified>
</cp:coreProperties>
</file>